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7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A5EB950-2A03-4D70-B9EA-6FF3A7951E6E}" v="1" dt="2025-11-21T17:29:01.7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55" autoAdjust="0"/>
    <p:restoredTop sz="94660"/>
  </p:normalViewPr>
  <p:slideViewPr>
    <p:cSldViewPr snapToGrid="0">
      <p:cViewPr varScale="1">
        <p:scale>
          <a:sx n="43" d="100"/>
          <a:sy n="43" d="100"/>
        </p:scale>
        <p:origin x="60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ghan Moran" userId="30256bc4-a161-4226-a2d6-4e8766bd09d0" providerId="ADAL" clId="{8B0668C6-C7D0-4AFB-9B8E-773148CE68EF}"/>
    <pc:docChg chg="addSld delSld modSld">
      <pc:chgData name="Meghan Moran" userId="30256bc4-a161-4226-a2d6-4e8766bd09d0" providerId="ADAL" clId="{8B0668C6-C7D0-4AFB-9B8E-773148CE68EF}" dt="2025-11-21T17:29:03.601" v="1" actId="47"/>
      <pc:docMkLst>
        <pc:docMk/>
      </pc:docMkLst>
      <pc:sldChg chg="del">
        <pc:chgData name="Meghan Moran" userId="30256bc4-a161-4226-a2d6-4e8766bd09d0" providerId="ADAL" clId="{8B0668C6-C7D0-4AFB-9B8E-773148CE68EF}" dt="2025-11-21T17:29:03.601" v="1" actId="47"/>
        <pc:sldMkLst>
          <pc:docMk/>
          <pc:sldMk cId="3779971660" sldId="374"/>
        </pc:sldMkLst>
      </pc:sldChg>
      <pc:sldChg chg="add">
        <pc:chgData name="Meghan Moran" userId="30256bc4-a161-4226-a2d6-4e8766bd09d0" providerId="ADAL" clId="{8B0668C6-C7D0-4AFB-9B8E-773148CE68EF}" dt="2025-11-21T17:29:01.729" v="0"/>
        <pc:sldMkLst>
          <pc:docMk/>
          <pc:sldMk cId="899721690" sldId="37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DC337-203F-6ACA-81AC-A8CD27A5AE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9D7B5D-55B0-0F5B-6BA0-DC90372DD4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04F32-11AA-CBE5-2813-45379BA1F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299BDA-A4D5-5426-1C32-74827FEEF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5029E-681C-D8EA-A9CB-183241D8F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90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EB47E-F2C1-413F-B074-279E0D348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D872DB-08DE-46C0-9BE7-C9EA6F70CF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F2B9D5-E42C-8729-D31B-A4C4FFFC2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23C39-0265-A664-15E0-F0096A2F5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B05800-E7E3-DEA3-F080-8507E4D9C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546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4666AB-3A2A-CAEC-CCB0-2D71536B3C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2294C-2D59-A5D6-2BB4-5F224E22D2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C372F-A7A7-E7B0-F777-9CFD14855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BE6756-259C-5BDB-275F-725DCB4E8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52E30-8BB8-6455-1F33-5535A5DF3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901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A5150-CAE5-4302-4470-A41AD735A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5F923-B478-8748-7F7D-2781A5F69C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D437E4-8C26-5284-E89D-FACD8C431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7BBD2-44EF-10AD-EA54-166AB146C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19E2B-FA57-B58C-DA85-FACDE38D7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5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4D0AF-E17E-151C-EE82-E6F69A538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EE6578-DA8B-EE9A-84AE-827EC7379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F4B51F-933B-BF26-83C2-3C0F127D0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B3783-29CD-7E76-8B07-F52AFCF91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079BBE-A69E-4052-D46A-EFE735E63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462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78B95-B489-6691-A121-9CC6C4B712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C91E10-CD3D-3EDC-DFB0-803D967D56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333D40-635E-6ABB-1B03-872F3BE745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E6EE93-F983-49B8-E287-350ACD5A5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60D05B-83E8-E736-62CA-978BDAC89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93DB88-7FCA-805B-B25D-A15ED303A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05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2B4D2-B742-74AD-7E4F-1C36C8BF38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63AD43-55EA-D2A5-C714-0F0235245F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4C5E5-8085-43E6-0982-479004178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4259B2-C329-5225-AFC6-1C45D9A8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7D774B-43D2-0E6E-192B-05B59342A2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031BED-9BF2-1594-9AF9-A8C3F8574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4B5B88-637B-2382-48A0-432B9BCA7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96C8DB-709D-927A-830E-6AA222BC3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174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449D5E-0BC9-365E-FBD0-5C50E02B1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96A71A-9EAC-E539-A92E-A8C4A2D89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358E02-2118-7788-D756-007982747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31ED9F-AC4C-29FD-4CB8-C8FF1F5E6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472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886813-0D54-97B1-9E59-858D295EA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2F8018-E02D-A9CE-D719-36E85435A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90113A-1DA2-D8A0-5CA8-0ED75C829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972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3400C-96A9-3332-9F54-0E6371A59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E3DF7-C799-1095-64F8-E94B03841B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E82F2-DA81-4ABB-2630-6746143C0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19D5D2-2449-89D1-2373-E4AF24D1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9B6FAA-D7A8-C85A-18DA-83379ECCA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519064-18BA-1CDB-19AA-2A29554E3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188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87BDD-9463-3AED-548E-435A5322B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4E64A2-3F6D-03EB-E76D-5046D5A6C0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43AA9C-110C-6439-5410-F3CF4C84B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390388-7848-4138-531B-EF7F15E21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5C8E1D-B33D-C775-C3DB-16B67AF93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B3E97-98B0-29A3-9A63-2EA4A8910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73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B1D7BD-CDAC-68DD-C607-2E71AB3D3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BC608A-12FF-754B-AF73-6DDBDF80C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060F9-A318-F7D9-7F7A-431771AB91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5AA70-A864-7D31-742F-E7BD4D0D15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1EC38-407C-52B9-1DA8-1E0EBDCB00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81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58322" y="-67563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097692" y="272247"/>
          <a:ext cx="10529735" cy="1748927"/>
        </p:xfrm>
        <a:graphic>
          <a:graphicData uri="http://schemas.openxmlformats.org/drawingml/2006/table">
            <a:tbl>
              <a:tblPr/>
              <a:tblGrid>
                <a:gridCol w="2114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03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2204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9032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90327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9032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2204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1411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43197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90327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14119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243197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182397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90327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182397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182397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190327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214119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182397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190327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222049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  <a:gridCol w="214119">
                  <a:extLst>
                    <a:ext uri="{9D8B030D-6E8A-4147-A177-3AD203B41FA5}">
                      <a16:colId xmlns:a16="http://schemas.microsoft.com/office/drawing/2014/main" val="20026"/>
                    </a:ext>
                  </a:extLst>
                </a:gridCol>
                <a:gridCol w="243197">
                  <a:extLst>
                    <a:ext uri="{9D8B030D-6E8A-4147-A177-3AD203B41FA5}">
                      <a16:colId xmlns:a16="http://schemas.microsoft.com/office/drawing/2014/main" val="20027"/>
                    </a:ext>
                  </a:extLst>
                </a:gridCol>
                <a:gridCol w="200901">
                  <a:extLst>
                    <a:ext uri="{9D8B030D-6E8A-4147-A177-3AD203B41FA5}">
                      <a16:colId xmlns:a16="http://schemas.microsoft.com/office/drawing/2014/main" val="20028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29"/>
                    </a:ext>
                  </a:extLst>
                </a:gridCol>
                <a:gridCol w="222049">
                  <a:extLst>
                    <a:ext uri="{9D8B030D-6E8A-4147-A177-3AD203B41FA5}">
                      <a16:colId xmlns:a16="http://schemas.microsoft.com/office/drawing/2014/main" val="20030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31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32"/>
                    </a:ext>
                  </a:extLst>
                </a:gridCol>
                <a:gridCol w="214119">
                  <a:extLst>
                    <a:ext uri="{9D8B030D-6E8A-4147-A177-3AD203B41FA5}">
                      <a16:colId xmlns:a16="http://schemas.microsoft.com/office/drawing/2014/main" val="20033"/>
                    </a:ext>
                  </a:extLst>
                </a:gridCol>
                <a:gridCol w="232623">
                  <a:extLst>
                    <a:ext uri="{9D8B030D-6E8A-4147-A177-3AD203B41FA5}">
                      <a16:colId xmlns:a16="http://schemas.microsoft.com/office/drawing/2014/main" val="20034"/>
                    </a:ext>
                  </a:extLst>
                </a:gridCol>
                <a:gridCol w="245840">
                  <a:extLst>
                    <a:ext uri="{9D8B030D-6E8A-4147-A177-3AD203B41FA5}">
                      <a16:colId xmlns:a16="http://schemas.microsoft.com/office/drawing/2014/main" val="20035"/>
                    </a:ext>
                  </a:extLst>
                </a:gridCol>
                <a:gridCol w="243197">
                  <a:extLst>
                    <a:ext uri="{9D8B030D-6E8A-4147-A177-3AD203B41FA5}">
                      <a16:colId xmlns:a16="http://schemas.microsoft.com/office/drawing/2014/main" val="20036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37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38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39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40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41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42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43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44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45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46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47"/>
                    </a:ext>
                  </a:extLst>
                </a:gridCol>
                <a:gridCol w="211475">
                  <a:extLst>
                    <a:ext uri="{9D8B030D-6E8A-4147-A177-3AD203B41FA5}">
                      <a16:colId xmlns:a16="http://schemas.microsoft.com/office/drawing/2014/main" val="20048"/>
                    </a:ext>
                  </a:extLst>
                </a:gridCol>
                <a:gridCol w="225613">
                  <a:extLst>
                    <a:ext uri="{9D8B030D-6E8A-4147-A177-3AD203B41FA5}">
                      <a16:colId xmlns:a16="http://schemas.microsoft.com/office/drawing/2014/main" val="20049"/>
                    </a:ext>
                  </a:extLst>
                </a:gridCol>
              </a:tblGrid>
              <a:tr h="323050"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41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42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B4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15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55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B5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C5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F5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46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E6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F6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17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67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87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A7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A7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B7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D7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E3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E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E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E0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F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E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DC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DC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D9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BD9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7D6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3050"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2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79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93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4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82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77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91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85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6B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35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8A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04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36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6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26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6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E4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88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66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98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67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EB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95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89C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3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1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3C2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5BA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DC8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A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B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C2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A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87D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FA5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B8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AD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88C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CD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D9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F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8AA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B8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3050"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47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2A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A4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19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B3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FA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C2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29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1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25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B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272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2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39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C9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87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CA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C7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88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B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3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E6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3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E5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DA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F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D8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D9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E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D9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DC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E6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3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D8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4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DA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E4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79777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3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rn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b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9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00a9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p1a3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2rl2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amf6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r2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9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c5a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c4e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c4a2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2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lnt6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15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x8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cn2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am8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m</a:t>
                      </a:r>
                    </a:p>
                  </a:txBody>
                  <a:tcPr marL="7950" marR="7950" marT="7950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ga2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ra4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hde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ff1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ql3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ras2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st3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k1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em30b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rin3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i1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zp2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a1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gb8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c2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ud7a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ig4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2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n3a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e5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r1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h3</a:t>
                      </a:r>
                    </a:p>
                  </a:txBody>
                  <a:tcPr marL="7950" marR="7950" marT="7950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50" marR="7950" marT="795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76668" y="272247"/>
            <a:ext cx="550554" cy="377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097689" y="1853041"/>
          <a:ext cx="10171669" cy="1609781"/>
        </p:xfrm>
        <a:graphic>
          <a:graphicData uri="http://schemas.openxmlformats.org/drawingml/2006/table">
            <a:tbl>
              <a:tblPr/>
              <a:tblGrid>
                <a:gridCol w="2057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517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603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8517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8517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8517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1603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0832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7745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85173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08320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236611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177458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85173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177458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177458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185173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208320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177458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185173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216035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  <a:gridCol w="208320">
                  <a:extLst>
                    <a:ext uri="{9D8B030D-6E8A-4147-A177-3AD203B41FA5}">
                      <a16:colId xmlns:a16="http://schemas.microsoft.com/office/drawing/2014/main" val="20026"/>
                    </a:ext>
                  </a:extLst>
                </a:gridCol>
                <a:gridCol w="236611">
                  <a:extLst>
                    <a:ext uri="{9D8B030D-6E8A-4147-A177-3AD203B41FA5}">
                      <a16:colId xmlns:a16="http://schemas.microsoft.com/office/drawing/2014/main" val="20027"/>
                    </a:ext>
                  </a:extLst>
                </a:gridCol>
                <a:gridCol w="195461">
                  <a:extLst>
                    <a:ext uri="{9D8B030D-6E8A-4147-A177-3AD203B41FA5}">
                      <a16:colId xmlns:a16="http://schemas.microsoft.com/office/drawing/2014/main" val="20028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29"/>
                    </a:ext>
                  </a:extLst>
                </a:gridCol>
                <a:gridCol w="216035">
                  <a:extLst>
                    <a:ext uri="{9D8B030D-6E8A-4147-A177-3AD203B41FA5}">
                      <a16:colId xmlns:a16="http://schemas.microsoft.com/office/drawing/2014/main" val="20030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31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32"/>
                    </a:ext>
                  </a:extLst>
                </a:gridCol>
                <a:gridCol w="208320">
                  <a:extLst>
                    <a:ext uri="{9D8B030D-6E8A-4147-A177-3AD203B41FA5}">
                      <a16:colId xmlns:a16="http://schemas.microsoft.com/office/drawing/2014/main" val="20033"/>
                    </a:ext>
                  </a:extLst>
                </a:gridCol>
                <a:gridCol w="226323">
                  <a:extLst>
                    <a:ext uri="{9D8B030D-6E8A-4147-A177-3AD203B41FA5}">
                      <a16:colId xmlns:a16="http://schemas.microsoft.com/office/drawing/2014/main" val="20034"/>
                    </a:ext>
                  </a:extLst>
                </a:gridCol>
                <a:gridCol w="239182">
                  <a:extLst>
                    <a:ext uri="{9D8B030D-6E8A-4147-A177-3AD203B41FA5}">
                      <a16:colId xmlns:a16="http://schemas.microsoft.com/office/drawing/2014/main" val="20035"/>
                    </a:ext>
                  </a:extLst>
                </a:gridCol>
                <a:gridCol w="236611">
                  <a:extLst>
                    <a:ext uri="{9D8B030D-6E8A-4147-A177-3AD203B41FA5}">
                      <a16:colId xmlns:a16="http://schemas.microsoft.com/office/drawing/2014/main" val="20036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37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38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39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0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1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2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3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4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5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6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7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8"/>
                    </a:ext>
                  </a:extLst>
                </a:gridCol>
                <a:gridCol w="205748">
                  <a:extLst>
                    <a:ext uri="{9D8B030D-6E8A-4147-A177-3AD203B41FA5}">
                      <a16:colId xmlns:a16="http://schemas.microsoft.com/office/drawing/2014/main" val="20049"/>
                    </a:ext>
                  </a:extLst>
                </a:gridCol>
              </a:tblGrid>
              <a:tr h="303732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1A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4B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3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5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3732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55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57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8B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1B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FA5D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09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3732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4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F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BBB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1C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6C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B8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9858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tx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gals5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4ha3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grg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l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k32a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scam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at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3st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o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t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h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at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prss15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1a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3b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3g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am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1097690" y="3462824"/>
          <a:ext cx="10515599" cy="1717111"/>
        </p:xfrm>
        <a:graphic>
          <a:graphicData uri="http://schemas.openxmlformats.org/drawingml/2006/table">
            <a:tbl>
              <a:tblPr/>
              <a:tblGrid>
                <a:gridCol w="2127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233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2334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244611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223340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26"/>
                    </a:ext>
                  </a:extLst>
                </a:gridCol>
                <a:gridCol w="244611">
                  <a:extLst>
                    <a:ext uri="{9D8B030D-6E8A-4147-A177-3AD203B41FA5}">
                      <a16:colId xmlns:a16="http://schemas.microsoft.com/office/drawing/2014/main" val="20027"/>
                    </a:ext>
                  </a:extLst>
                </a:gridCol>
                <a:gridCol w="202070">
                  <a:extLst>
                    <a:ext uri="{9D8B030D-6E8A-4147-A177-3AD203B41FA5}">
                      <a16:colId xmlns:a16="http://schemas.microsoft.com/office/drawing/2014/main" val="20028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29"/>
                    </a:ext>
                  </a:extLst>
                </a:gridCol>
                <a:gridCol w="223340">
                  <a:extLst>
                    <a:ext uri="{9D8B030D-6E8A-4147-A177-3AD203B41FA5}">
                      <a16:colId xmlns:a16="http://schemas.microsoft.com/office/drawing/2014/main" val="20030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1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2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33"/>
                    </a:ext>
                  </a:extLst>
                </a:gridCol>
                <a:gridCol w="233975">
                  <a:extLst>
                    <a:ext uri="{9D8B030D-6E8A-4147-A177-3AD203B41FA5}">
                      <a16:colId xmlns:a16="http://schemas.microsoft.com/office/drawing/2014/main" val="20034"/>
                    </a:ext>
                  </a:extLst>
                </a:gridCol>
                <a:gridCol w="247269">
                  <a:extLst>
                    <a:ext uri="{9D8B030D-6E8A-4147-A177-3AD203B41FA5}">
                      <a16:colId xmlns:a16="http://schemas.microsoft.com/office/drawing/2014/main" val="20035"/>
                    </a:ext>
                  </a:extLst>
                </a:gridCol>
                <a:gridCol w="244611">
                  <a:extLst>
                    <a:ext uri="{9D8B030D-6E8A-4147-A177-3AD203B41FA5}">
                      <a16:colId xmlns:a16="http://schemas.microsoft.com/office/drawing/2014/main" val="20036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7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8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9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0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1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2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3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4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5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6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7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8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9"/>
                    </a:ext>
                  </a:extLst>
                </a:gridCol>
              </a:tblGrid>
              <a:tr h="299496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8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8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A6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28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29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F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4B1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AE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9496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FF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D9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4A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AD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8A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3B9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E9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E78C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59F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9496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63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A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58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7A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88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D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96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DB6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878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B0D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A7A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99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96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B0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818623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tx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6l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z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tnl8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2h2aa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167b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qp8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ox3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zmc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xa9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a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5a4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rx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po2l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1097688" y="5173312"/>
          <a:ext cx="10515599" cy="1711856"/>
        </p:xfrm>
        <a:graphic>
          <a:graphicData uri="http://schemas.openxmlformats.org/drawingml/2006/table">
            <a:tbl>
              <a:tblPr/>
              <a:tblGrid>
                <a:gridCol w="2127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233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2334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244611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183458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191434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223340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26"/>
                    </a:ext>
                  </a:extLst>
                </a:gridCol>
                <a:gridCol w="244611">
                  <a:extLst>
                    <a:ext uri="{9D8B030D-6E8A-4147-A177-3AD203B41FA5}">
                      <a16:colId xmlns:a16="http://schemas.microsoft.com/office/drawing/2014/main" val="20027"/>
                    </a:ext>
                  </a:extLst>
                </a:gridCol>
                <a:gridCol w="202070">
                  <a:extLst>
                    <a:ext uri="{9D8B030D-6E8A-4147-A177-3AD203B41FA5}">
                      <a16:colId xmlns:a16="http://schemas.microsoft.com/office/drawing/2014/main" val="20028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29"/>
                    </a:ext>
                  </a:extLst>
                </a:gridCol>
                <a:gridCol w="223340">
                  <a:extLst>
                    <a:ext uri="{9D8B030D-6E8A-4147-A177-3AD203B41FA5}">
                      <a16:colId xmlns:a16="http://schemas.microsoft.com/office/drawing/2014/main" val="20030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1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2"/>
                    </a:ext>
                  </a:extLst>
                </a:gridCol>
                <a:gridCol w="215364">
                  <a:extLst>
                    <a:ext uri="{9D8B030D-6E8A-4147-A177-3AD203B41FA5}">
                      <a16:colId xmlns:a16="http://schemas.microsoft.com/office/drawing/2014/main" val="20033"/>
                    </a:ext>
                  </a:extLst>
                </a:gridCol>
                <a:gridCol w="233975">
                  <a:extLst>
                    <a:ext uri="{9D8B030D-6E8A-4147-A177-3AD203B41FA5}">
                      <a16:colId xmlns:a16="http://schemas.microsoft.com/office/drawing/2014/main" val="20034"/>
                    </a:ext>
                  </a:extLst>
                </a:gridCol>
                <a:gridCol w="247269">
                  <a:extLst>
                    <a:ext uri="{9D8B030D-6E8A-4147-A177-3AD203B41FA5}">
                      <a16:colId xmlns:a16="http://schemas.microsoft.com/office/drawing/2014/main" val="20035"/>
                    </a:ext>
                  </a:extLst>
                </a:gridCol>
                <a:gridCol w="244611">
                  <a:extLst>
                    <a:ext uri="{9D8B030D-6E8A-4147-A177-3AD203B41FA5}">
                      <a16:colId xmlns:a16="http://schemas.microsoft.com/office/drawing/2014/main" val="20036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7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8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39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0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1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2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3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4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5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6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7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8"/>
                    </a:ext>
                  </a:extLst>
                </a:gridCol>
                <a:gridCol w="212705">
                  <a:extLst>
                    <a:ext uri="{9D8B030D-6E8A-4147-A177-3AD203B41FA5}">
                      <a16:colId xmlns:a16="http://schemas.microsoft.com/office/drawing/2014/main" val="20049"/>
                    </a:ext>
                  </a:extLst>
                </a:gridCol>
              </a:tblGrid>
              <a:tr h="335658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11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1E1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4E4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95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707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E3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E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1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DC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D9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D9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D8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D7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D6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D5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3D4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ED1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D1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D1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F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F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CE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6CD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CD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CB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CB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3CB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CA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C9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C4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C1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C1E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B3D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B3D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AE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EAD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7AA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A7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1A6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BA3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39E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99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37A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35658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75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83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70C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CEE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E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3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E0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E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3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E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F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3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C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D9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DB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CC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D0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D8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3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D4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E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B4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D1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C8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D0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C3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D0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A8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C3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C4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6A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B6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1A6D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FA5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B76C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35658"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E3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35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545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3A3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CB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E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E0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DF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DAE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E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D3E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CC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D8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DF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D7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C9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CA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F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5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D1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3CB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E0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D0E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C5E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ABD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D7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99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C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B8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A4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5A0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BAC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C9B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A0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999" marR="7999" marT="7999" marB="0" vert="vert27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04882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bx5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ya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6a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lec8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tnl8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s2c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j5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13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f17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p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c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g16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ib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nf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oln3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a1b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a1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kr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51b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tssb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gs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p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dn15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g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4a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17a6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d17b6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5a48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ra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al3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51a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pine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bp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ep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bt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kal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2h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35g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f3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8b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l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d3b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kg2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bp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zp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al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2c24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4f1</a:t>
                      </a:r>
                    </a:p>
                  </a:txBody>
                  <a:tcPr marL="7999" marR="7999" marT="7999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21955" y="1853041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52848" y="3595586"/>
            <a:ext cx="550554" cy="377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2848" y="5300818"/>
            <a:ext cx="550554" cy="377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70605" y="3318816"/>
            <a:ext cx="4977711" cy="288012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7747686" y="364046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og F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03451" y="23061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84792" y="59498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04065" y="95935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4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84792" y="177282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66133" y="213719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85406" y="250157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4d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30792" y="339199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12133" y="375636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31406" y="412073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4d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62943" y="515476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d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44284" y="551913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63557" y="588351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4d</a:t>
            </a:r>
          </a:p>
        </p:txBody>
      </p:sp>
    </p:spTree>
    <p:extLst>
      <p:ext uri="{BB962C8B-B14F-4D97-AF65-F5344CB8AC3E}">
        <p14:creationId xmlns:p14="http://schemas.microsoft.com/office/powerpoint/2010/main" val="899721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58</Words>
  <Application>Microsoft Office PowerPoint</Application>
  <PresentationFormat>Widescreen</PresentationFormat>
  <Paragraphs>1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>Rush Universit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ghan Moran</dc:creator>
  <cp:lastModifiedBy>Meghan Moran</cp:lastModifiedBy>
  <cp:revision>15</cp:revision>
  <dcterms:created xsi:type="dcterms:W3CDTF">2025-11-21T17:16:35Z</dcterms:created>
  <dcterms:modified xsi:type="dcterms:W3CDTF">2025-11-21T17:29:07Z</dcterms:modified>
</cp:coreProperties>
</file>